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93" r:id="rId3"/>
    <p:sldId id="300" r:id="rId4"/>
    <p:sldId id="302" r:id="rId5"/>
    <p:sldId id="301" r:id="rId6"/>
    <p:sldId id="294" r:id="rId7"/>
    <p:sldId id="30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14"/>
  </p:normalViewPr>
  <p:slideViewPr>
    <p:cSldViewPr snapToGrid="0" snapToObjects="1">
      <p:cViewPr varScale="1">
        <p:scale>
          <a:sx n="112" d="100"/>
          <a:sy n="112" d="100"/>
        </p:scale>
        <p:origin x="5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CCD49-D668-F64D-81A0-D45C31468D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0A6A24-2FEE-244F-951D-9A892BF37C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49F09-7BAE-494A-9200-5D97B3FFA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A30B5A-454A-EF4E-871B-946B8FF62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EFEF05-9857-AE46-A515-732FA77A5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232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2CE885-2D29-9145-A99A-8960FBE4EC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4C214E-ABA3-014A-866A-825F257F25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73AAE-4A3E-DF48-A10B-EE196413A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CEE8B6-511E-6A4D-93CD-5037FF144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136BE-662A-9749-979F-8B1387F1B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7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80B683-CD89-EA41-9432-36D8C735B7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7151E8-6029-A549-9A04-EAB6CF56E6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CD48E-3F7E-5F41-A7E6-3B10103E6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8867B9-0A7A-DA44-82D6-D6F92417D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6FA735-AF18-924E-B08F-EBFD358B2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727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6985EC-0263-5F47-BB80-EBA0DD4FCA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A59F9A-81F9-C948-86F3-82F279D839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0CC97C-0C32-7C4E-A440-F84B75423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910177-07BE-1349-93F7-F6B86EDCB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F22C4D-977D-A54D-B5A4-4AE9DBE10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121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6E3CC4-6A62-FD4D-8B7D-604EAF5B7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7B81D5-2A24-BB45-842F-35B7E3EC6A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2EB9FE-D526-924C-8AF6-33BF276AC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92C3C4-EE43-A448-8052-06DDB3098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6DC75D-9F63-6447-A4BC-5504F6433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27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16BC7-EFE3-4040-9D70-253E213C38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74195D-4EE9-8745-A4AA-D4AE0B9B90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2D9575-0530-094A-9206-B65DFE737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5747AA-9F31-0448-88D7-9AA03BC64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7581B2-EABA-9B4C-A60B-DA169831C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48972D-5742-DC4E-8DFF-F1B0791B7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580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3F2F2-F77C-484D-A86D-6DC2B1BC4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27378-37E2-C644-A17E-90FCD39E0F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303C5C-42BB-394A-B665-DB706B5312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07DFCB-2425-BB45-9CAA-A55B9B731D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36002F-3818-174D-B7AC-8FE22C5C93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D7ED05-2569-9946-B013-605D082DF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71EE49-0AD6-0D44-A6A5-868E47669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8A46AC-1241-7947-9C99-9F181717F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59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8724D9-2925-4B40-B756-0EDA0ACAB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F0560D-A08D-3B43-AEB3-821207DCC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3D3E06-9BEE-044B-BD6F-4AA79270A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F54142-0059-154A-ABD0-D760C3FCF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338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E64C1C-1003-7F41-A62D-A42794212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0ADC7D8-F1F6-C641-9368-6A83D72DD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C4DCD9-2630-DF4C-A329-A34721F1A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949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928C3-430B-0B41-A478-193151565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C886D1-60D7-2046-92B6-0787D1048A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86699D-A77F-3945-BD79-8026E754D7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05B477-2CD3-9C43-BEBC-545F2B4A5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BFAFC0-4696-9246-B42C-9A4095331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3C1BB7-D087-9D40-B29B-B170494DA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38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8A5BF-E6F8-3F45-880E-9E237FD98A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6D247E-5CFE-664A-9A8B-C547616706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C2125C-3128-AD40-90DA-CD4EA4FB90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BA3716-E333-2041-B0E6-D70977079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56B9AC-52E7-D648-B035-97B0C00A4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A002DE-A64C-8745-BD6D-169A1AE49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995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CBC8B9-4331-9C45-8259-4E320D0D5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BF939F-DF67-F344-9F6F-2ABD4FE896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B50EEE-AACD-E248-B40B-EC3421F295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FA672-4CE3-CF43-A806-8CBCA7C102CF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1A3FDA-7888-F142-B695-8DCA0A1890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FF9B66-221A-294B-B36A-4A6D06C87C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46505-0584-9E4F-9B53-14EF841178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885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235200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Resuscitation Leadership Training  </a:t>
            </a:r>
            <a:br>
              <a:rPr lang="en-US" dirty="0"/>
            </a:br>
            <a:br>
              <a:rPr lang="en-US" dirty="0"/>
            </a:br>
            <a:r>
              <a:rPr lang="en-US" sz="4400" dirty="0"/>
              <a:t>Simulation Case: ST-Elevation Myocardial Infarction and Ventricular Fibrillation Arrest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202238"/>
            <a:ext cx="9144000" cy="1655762"/>
          </a:xfrm>
        </p:spPr>
        <p:txBody>
          <a:bodyPr/>
          <a:lstStyle/>
          <a:p>
            <a:r>
              <a:rPr lang="en-US" dirty="0"/>
              <a:t>All Material Author Own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64416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D4544-EE60-E34B-B30E-120E6A1993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KG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1C378A0-2CC9-4942-A566-D3C92E1272C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62" t="2482" r="3880" b="3900"/>
          <a:stretch/>
        </p:blipFill>
        <p:spPr>
          <a:xfrm>
            <a:off x="2152650" y="1971675"/>
            <a:ext cx="7448550" cy="37719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61104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CUS - Echo</a:t>
            </a:r>
          </a:p>
        </p:txBody>
      </p:sp>
      <p:pic>
        <p:nvPicPr>
          <p:cNvPr id="4" name="Decreased EF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444262" y="1336431"/>
            <a:ext cx="6693877" cy="50204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22962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1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CUS - Lung</a:t>
            </a:r>
          </a:p>
        </p:txBody>
      </p:sp>
      <p:pic>
        <p:nvPicPr>
          <p:cNvPr id="4" name="703727_20131011_cardio_0007_dvd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032000" y="1930400"/>
            <a:ext cx="6901586" cy="364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472461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00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Normal IVC">
            <a:hlinkClick r:id="" action="ppaction://media"/>
            <a:extLst>
              <a:ext uri="{FF2B5EF4-FFF2-40B4-BE49-F238E27FC236}">
                <a16:creationId xmlns:a16="http://schemas.microsoft.com/office/drawing/2014/main" id="{DED1E85E-19DC-DC4C-A34F-4A72430040F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829917" y="1417638"/>
            <a:ext cx="6218656" cy="4663992"/>
          </a:xfrm>
          <a:prstGeom prst="rect">
            <a:avLst/>
          </a:prstGeom>
        </p:spPr>
      </p:pic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POCUS </a:t>
            </a:r>
            <a:r>
              <a:rPr lang="en-US" dirty="0"/>
              <a:t>- IVC</a:t>
            </a:r>
          </a:p>
        </p:txBody>
      </p:sp>
    </p:spTree>
    <p:extLst>
      <p:ext uri="{BB962C8B-B14F-4D97-AF65-F5344CB8AC3E}">
        <p14:creationId xmlns:p14="http://schemas.microsoft.com/office/powerpoint/2010/main" val="2972453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2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6FC42-50C1-1440-BC06-5CF00ACA61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0A86102-F0B0-CB4D-8C7C-AA084EFD09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8900" y="1417638"/>
            <a:ext cx="6324600" cy="459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54048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BG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404655" y="1417639"/>
            <a:ext cx="6041571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ood gas values</a:t>
            </a:r>
          </a:p>
          <a:p>
            <a:r>
              <a:rPr lang="en-US" b="1" i="1" dirty="0"/>
              <a:t>	pH			7.31</a:t>
            </a:r>
            <a:endParaRPr lang="en-US" dirty="0"/>
          </a:p>
          <a:p>
            <a:r>
              <a:rPr lang="en-US" b="1" dirty="0"/>
              <a:t>	</a:t>
            </a:r>
            <a:r>
              <a:rPr lang="en-US" dirty="0"/>
              <a:t>pCO2			41	mmHg</a:t>
            </a:r>
          </a:p>
          <a:p>
            <a:r>
              <a:rPr lang="en-US" dirty="0"/>
              <a:t>	pO2			17	mmHg</a:t>
            </a:r>
          </a:p>
          <a:p>
            <a:r>
              <a:rPr lang="en-US" dirty="0"/>
              <a:t>Oximetry values</a:t>
            </a:r>
          </a:p>
          <a:p>
            <a:r>
              <a:rPr lang="en-US" dirty="0"/>
              <a:t>	</a:t>
            </a:r>
            <a:r>
              <a:rPr lang="en-US" b="1" i="1" dirty="0" err="1"/>
              <a:t>ctHb</a:t>
            </a:r>
            <a:r>
              <a:rPr lang="en-US" b="1" i="1" dirty="0"/>
              <a:t>			12	g/</a:t>
            </a:r>
            <a:r>
              <a:rPr lang="en-US" b="1" i="1" dirty="0" err="1"/>
              <a:t>dL</a:t>
            </a:r>
            <a:endParaRPr lang="en-US" dirty="0"/>
          </a:p>
          <a:p>
            <a:r>
              <a:rPr lang="en-US" dirty="0"/>
              <a:t>	</a:t>
            </a:r>
            <a:r>
              <a:rPr lang="en-US" dirty="0" err="1"/>
              <a:t>Hctc</a:t>
            </a:r>
            <a:r>
              <a:rPr lang="en-US" dirty="0"/>
              <a:t>			36	%</a:t>
            </a:r>
          </a:p>
          <a:p>
            <a:r>
              <a:rPr lang="en-US" dirty="0"/>
              <a:t>	sO2			17.6	%</a:t>
            </a:r>
          </a:p>
          <a:p>
            <a:r>
              <a:rPr lang="en-US" dirty="0"/>
              <a:t>	</a:t>
            </a:r>
            <a:r>
              <a:rPr lang="en-US" dirty="0" err="1"/>
              <a:t>FMetHb</a:t>
            </a:r>
            <a:r>
              <a:rPr lang="en-US" dirty="0"/>
              <a:t>		0.1	%</a:t>
            </a:r>
          </a:p>
          <a:p>
            <a:r>
              <a:rPr lang="en-US" dirty="0"/>
              <a:t>Electrolyte values</a:t>
            </a:r>
          </a:p>
          <a:p>
            <a:r>
              <a:rPr lang="en-US" dirty="0"/>
              <a:t>	Na			139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	Cl			98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	Ca			1.06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Metabolite values</a:t>
            </a:r>
          </a:p>
          <a:p>
            <a:r>
              <a:rPr lang="en-US" dirty="0"/>
              <a:t>	</a:t>
            </a:r>
            <a:r>
              <a:rPr lang="en-US" dirty="0" err="1"/>
              <a:t>Gluc</a:t>
            </a:r>
            <a:r>
              <a:rPr lang="en-US" dirty="0"/>
              <a:t>			110	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	</a:t>
            </a:r>
            <a:r>
              <a:rPr lang="en-US" b="1" i="1" dirty="0"/>
              <a:t>Lac			2.2	</a:t>
            </a:r>
            <a:r>
              <a:rPr lang="en-US" b="1" i="1" dirty="0" err="1"/>
              <a:t>mmol</a:t>
            </a:r>
            <a:r>
              <a:rPr lang="en-US" b="1" i="1" dirty="0"/>
              <a:t>/L</a:t>
            </a:r>
            <a:endParaRPr lang="en-US" dirty="0"/>
          </a:p>
          <a:p>
            <a:r>
              <a:rPr lang="en-US" dirty="0"/>
              <a:t>Acid-base status</a:t>
            </a:r>
          </a:p>
          <a:p>
            <a:r>
              <a:rPr lang="en-US" dirty="0"/>
              <a:t>	cHCO3			22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</p:txBody>
      </p:sp>
    </p:spTree>
    <p:extLst>
      <p:ext uri="{BB962C8B-B14F-4D97-AF65-F5344CB8AC3E}">
        <p14:creationId xmlns:p14="http://schemas.microsoft.com/office/powerpoint/2010/main" val="3481343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57</Words>
  <Application>Microsoft Macintosh PowerPoint</Application>
  <PresentationFormat>Widescreen</PresentationFormat>
  <Paragraphs>26</Paragraphs>
  <Slides>7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Resuscitation Leadership Training    Simulation Case: ST-Elevation Myocardial Infarction and Ventricular Fibrillation Arrest</vt:lpstr>
      <vt:lpstr>EKG</vt:lpstr>
      <vt:lpstr>POCUS - Echo</vt:lpstr>
      <vt:lpstr>POCUS - Lung</vt:lpstr>
      <vt:lpstr>POCUS - IVC</vt:lpstr>
      <vt:lpstr>CXR</vt:lpstr>
      <vt:lpstr>VB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scitation Leadership Training    Simulation Case: ST-Elevation Myocardial Infarction and Ventricular Fibrillation Arrest</dc:title>
  <dc:creator>Microsoft Office User</dc:creator>
  <cp:lastModifiedBy>Microsoft Office User</cp:lastModifiedBy>
  <cp:revision>3</cp:revision>
  <dcterms:created xsi:type="dcterms:W3CDTF">2022-02-26T18:21:47Z</dcterms:created>
  <dcterms:modified xsi:type="dcterms:W3CDTF">2022-02-26T19:12:46Z</dcterms:modified>
</cp:coreProperties>
</file>